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4AA1A5-324F-4E44-AFE8-E95F60DE1D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01FD76-5EE0-4C2D-B27D-835D798A9D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8C375-1120-47C0-89F4-68A8DAD9C9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AE53E-7412-40DA-B790-E51C3913A4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C74E0-F163-4A36-9978-63FBA13857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9DF89-AA7E-4EFA-8A77-F0CC92F995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8FBCB-0962-4900-9247-2FEA5B98FF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54F81-0C2B-4037-9FA0-4FA15754F2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58C3A-BBF4-4FE7-B6AC-DFA76D344B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D97D6-FF1D-4069-B602-8541926E41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51F47-3B30-4958-934C-66EA621447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585D5-A642-4EE0-9A7D-3BCF11C6A7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736F5B-C181-4398-95D4-7AAF6014268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1371600" y="6400440"/>
            <a:ext cx="6400800" cy="304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ctr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rtial view of Gilgel Gibe Hydropower Reservoir are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1"/>
          <p:cNvPicPr/>
          <p:nvPr/>
        </p:nvPicPr>
        <p:blipFill>
          <a:blip r:embed="rId1"/>
          <a:stretch/>
        </p:blipFill>
        <p:spPr>
          <a:xfrm>
            <a:off x="152280" y="114480"/>
            <a:ext cx="8991720" cy="6286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/>
          </p:nvPr>
        </p:nvSpPr>
        <p:spPr>
          <a:xfrm>
            <a:off x="457200" y="6248520"/>
            <a:ext cx="8229600" cy="380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ntervie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3" descr="8"/>
          <p:cNvPicPr/>
          <p:nvPr/>
        </p:nvPicPr>
        <p:blipFill>
          <a:blip r:embed="rId1"/>
          <a:stretch/>
        </p:blipFill>
        <p:spPr>
          <a:xfrm>
            <a:off x="0" y="50760"/>
            <a:ext cx="9144000" cy="619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/>
          </p:nvPr>
        </p:nvSpPr>
        <p:spPr>
          <a:xfrm>
            <a:off x="304920" y="6248520"/>
            <a:ext cx="8229600" cy="304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ntervie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3" descr="6"/>
          <p:cNvPicPr/>
          <p:nvPr/>
        </p:nvPicPr>
        <p:blipFill>
          <a:blip r:embed="rId1"/>
          <a:stretch/>
        </p:blipFill>
        <p:spPr>
          <a:xfrm>
            <a:off x="0" y="58680"/>
            <a:ext cx="9144000" cy="6037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/>
          </p:nvPr>
        </p:nvSpPr>
        <p:spPr>
          <a:xfrm>
            <a:off x="457200" y="6477120"/>
            <a:ext cx="8229600" cy="380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uthors with one of the renowned traditional healer (second from left) and his familie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4" descr="2"/>
          <p:cNvPicPr/>
          <p:nvPr/>
        </p:nvPicPr>
        <p:blipFill>
          <a:blip r:embed="rId1"/>
          <a:stretch/>
        </p:blipFill>
        <p:spPr>
          <a:xfrm>
            <a:off x="0" y="60480"/>
            <a:ext cx="9144000" cy="6340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/>
          </p:nvPr>
        </p:nvSpPr>
        <p:spPr>
          <a:xfrm>
            <a:off x="457200" y="6477120"/>
            <a:ext cx="8229600" cy="380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edicinal plant collection from the fiel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5" descr="3"/>
          <p:cNvPicPr/>
          <p:nvPr/>
        </p:nvPicPr>
        <p:blipFill>
          <a:blip r:embed="rId1"/>
          <a:stretch/>
        </p:blipFill>
        <p:spPr>
          <a:xfrm>
            <a:off x="0" y="27000"/>
            <a:ext cx="9144000" cy="6221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/>
          </p:nvPr>
        </p:nvSpPr>
        <p:spPr>
          <a:xfrm>
            <a:off x="457200" y="6552720"/>
            <a:ext cx="8229600" cy="304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edicinal plant collection from the fiel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4" descr="7"/>
          <p:cNvPicPr/>
          <p:nvPr/>
        </p:nvPicPr>
        <p:blipFill>
          <a:blip r:embed="rId1"/>
          <a:stretch/>
        </p:blipFill>
        <p:spPr>
          <a:xfrm>
            <a:off x="0" y="228600"/>
            <a:ext cx="9144000" cy="6324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0T12:26:09Z</dcterms:created>
  <dc:creator>dell</dc:creator>
  <dc:description/>
  <dc:language>en-US</dc:language>
  <cp:lastModifiedBy>Andrea Pieroni</cp:lastModifiedBy>
  <dcterms:modified xsi:type="dcterms:W3CDTF">2008-04-21T14:36:18Z</dcterms:modified>
  <cp:revision>5</cp:revision>
  <dc:subject/>
  <dc:title>Slide 1</dc:title>
</cp:coreProperties>
</file>